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0" r:id="rId2"/>
    <p:sldId id="256" r:id="rId3"/>
    <p:sldId id="262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1794" y="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26/03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6/03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6/03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6/03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6/03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6/03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6/03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6/03/2025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6/03/2025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6/03/2025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6/03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6/03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26/03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hyperlink" Target="http://creativecommons.org/licenses/by/4.0/" TargetMode="Externa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hyperlink" Target="http://creativecommons.org/licenses/by/4.0/" TargetMode="Externa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07504" y="5520714"/>
            <a:ext cx="7200800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Prasad et al (2025) Diabetologia DOI 10.1007/s00125-025-06419-1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5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Clinical utility of polygenic scores: possibilities and challenges</a:t>
            </a:r>
            <a:endParaRPr lang="en-GB" sz="2000" b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8D543C3-EED5-2374-1708-C1835C6DB95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49796" y="1270112"/>
            <a:ext cx="8244408" cy="42471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07504" y="5787841"/>
            <a:ext cx="7128792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1600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Prasad et al (2025) </a:t>
            </a: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abetologia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DOI 10.1007/s00125-025-06419-1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5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2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  <a:p>
            <a:endParaRPr lang="en-GB" sz="1200" dirty="0"/>
          </a:p>
        </p:txBody>
      </p:sp>
      <p:sp>
        <p:nvSpPr>
          <p:cNvPr id="8" name="TextBox 7"/>
          <p:cNvSpPr txBox="1"/>
          <p:nvPr/>
        </p:nvSpPr>
        <p:spPr>
          <a:xfrm>
            <a:off x="251520" y="272842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Type 2 diabetes: risk stratification and classification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50B61D92-BBA4-9A9D-C306-BE56F624925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5780" y="1012382"/>
            <a:ext cx="8532440" cy="4648866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07504" y="5733256"/>
            <a:ext cx="698477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Prasad et al (2025) </a:t>
            </a:r>
            <a:r>
              <a:rPr kumimoji="0" lang="en-GB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Diabetologia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 DOI 10.1007/s00125-025-06419-1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5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2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  <a:p>
            <a:endParaRPr lang="en-GB" sz="1200" dirty="0">
              <a:highlight>
                <a:srgbClr val="FFFF00"/>
              </a:highlight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95536" y="332656"/>
            <a:ext cx="820891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Challenges around clinical implementation of polygenic scores in understudied/diverse populations</a:t>
            </a:r>
            <a:endParaRPr lang="en-GB" sz="2000" b="1" dirty="0"/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74A78CCA-B325-6394-5646-F626F7CB461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02232" y="1340768"/>
            <a:ext cx="4139537" cy="42484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559605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0</Words>
  <Application>Microsoft Office PowerPoint</Application>
  <PresentationFormat>On-screen Show (4:3)</PresentationFormat>
  <Paragraphs>14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50</cp:revision>
  <dcterms:created xsi:type="dcterms:W3CDTF">2016-06-15T12:53:43Z</dcterms:created>
  <dcterms:modified xsi:type="dcterms:W3CDTF">2025-03-26T12:47:46Z</dcterms:modified>
</cp:coreProperties>
</file>